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  <a:srgbClr val="FF00FF"/>
    <a:srgbClr val="0000FF"/>
    <a:srgbClr val="800000"/>
    <a:srgbClr val="6600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858" autoAdjust="0"/>
    <p:restoredTop sz="86810" autoAdjust="0"/>
  </p:normalViewPr>
  <p:slideViewPr>
    <p:cSldViewPr>
      <p:cViewPr varScale="1">
        <p:scale>
          <a:sx n="73" d="100"/>
          <a:sy n="73" d="100"/>
        </p:scale>
        <p:origin x="2274" y="5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F5CF5F0-A185-432C-82C1-DB1F4BB881D7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368D9E-EFE5-4006-9788-5123A72728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42513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6 Fig. Comparative representation of transcriptome data in red and green </a:t>
            </a:r>
            <a:r>
              <a:rPr kumimoji="1" lang="en-US" altLang="ja-JP" sz="12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rilla</a:t>
            </a:r>
            <a:r>
              <a:rPr kumimoji="1" lang="en-US" altLang="ja-JP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lants. 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eviously identified genes encoding transcription factor(s) and enzymes, and the expression of </a:t>
            </a:r>
            <a:r>
              <a:rPr kumimoji="1" lang="en-US" altLang="ja-JP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igenes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re shown. The expression levels (TMM-normalized FPKM values) are displayed. Homologous genes in red and green </a:t>
            </a:r>
            <a:r>
              <a:rPr kumimoji="1" lang="en-US" altLang="ja-JP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rilla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dicate the reciprocal best-hit BLAST results. Asterisks represent </a:t>
            </a:r>
            <a:r>
              <a:rPr kumimoji="1" lang="en-US" altLang="ja-JP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false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iscovery rate (FDR) &lt; 0.05 obtained with the TCC package [43]. </a:t>
            </a:r>
            <a:r>
              <a:rPr kumimoji="1" lang="en-US" altLang="ja-JP" sz="1200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MM, Trimmed Mean of M values [63].</a:t>
            </a:r>
            <a:endParaRPr kumimoji="1" lang="ja-JP" altLang="ja-JP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F368D9E-EFE5-4006-9788-5123A727280B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73265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404664" y="1585317"/>
            <a:ext cx="774571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HLH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404664" y="3384376"/>
            <a:ext cx="684803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MYB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404664" y="4687693"/>
            <a:ext cx="825867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WD40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244422" y="2717929"/>
            <a:ext cx="23862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MYC-RP (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B024050</a:t>
            </a:r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244422" y="1599456"/>
            <a:ext cx="20569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F3G1 (</a:t>
            </a:r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AB103172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404664" y="5256584"/>
            <a:ext cx="65915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GST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1244422" y="3672408"/>
            <a:ext cx="2339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MYB-P1 (</a:t>
            </a:r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AB024053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1244422" y="4687693"/>
            <a:ext cx="21595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FWD (</a:t>
            </a:r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AB059642)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1244422" y="5280967"/>
            <a:ext cx="19502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GST (AB362191)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9" name="表 1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89210724"/>
              </p:ext>
            </p:extLst>
          </p:nvPr>
        </p:nvGraphicFramePr>
        <p:xfrm>
          <a:off x="1988840" y="1960052"/>
          <a:ext cx="1464497" cy="1809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08780"/>
                <a:gridCol w="555717"/>
              </a:tblGrid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solidFill>
                            <a:schemeClr val="bg1"/>
                          </a:solidFill>
                          <a:effectLst/>
                        </a:rPr>
                        <a:t>c21018_g1_i2</a:t>
                      </a:r>
                      <a:endParaRPr lang="en-US" sz="1100" b="0" i="0" u="none" strike="noStrike" dirty="0">
                        <a:solidFill>
                          <a:schemeClr val="bg1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solidFill>
                      <a:srgbClr val="FF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 smtClean="0">
                          <a:solidFill>
                            <a:schemeClr val="bg1"/>
                          </a:solidFill>
                          <a:effectLst/>
                        </a:rPr>
                        <a:t>281.9*</a:t>
                      </a:r>
                      <a:endParaRPr lang="en-US" altLang="ja-JP" sz="1100" b="0" i="0" u="none" strike="noStrike" dirty="0">
                        <a:solidFill>
                          <a:schemeClr val="bg1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solidFill>
                      <a:srgbClr val="FF00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20" name="表 1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13291829"/>
              </p:ext>
            </p:extLst>
          </p:nvPr>
        </p:nvGraphicFramePr>
        <p:xfrm>
          <a:off x="3486150" y="1954649"/>
          <a:ext cx="1192240" cy="1809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59828"/>
                <a:gridCol w="332412"/>
              </a:tblGrid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c21708_g2_i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 smtClean="0">
                          <a:effectLst/>
                        </a:rPr>
                        <a:t>34.5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solidFill>
                      <a:srgbClr val="00FF00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21" name="表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12197819"/>
              </p:ext>
            </p:extLst>
          </p:nvPr>
        </p:nvGraphicFramePr>
        <p:xfrm>
          <a:off x="3486150" y="3048486"/>
          <a:ext cx="1212989" cy="1809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52949"/>
                <a:gridCol w="360040"/>
              </a:tblGrid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c18367_g1_i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 smtClean="0">
                          <a:effectLst/>
                        </a:rPr>
                        <a:t>97.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solidFill>
                      <a:srgbClr val="00FF00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22" name="表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44322966"/>
              </p:ext>
            </p:extLst>
          </p:nvPr>
        </p:nvGraphicFramePr>
        <p:xfrm>
          <a:off x="1988840" y="3038961"/>
          <a:ext cx="1499265" cy="1809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95999"/>
                <a:gridCol w="503266"/>
              </a:tblGrid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solidFill>
                            <a:schemeClr val="bg1"/>
                          </a:solidFill>
                          <a:effectLst/>
                        </a:rPr>
                        <a:t>c19162_g1_i1</a:t>
                      </a:r>
                      <a:endParaRPr lang="en-US" sz="1100" b="0" i="0" u="none" strike="noStrike" dirty="0">
                        <a:solidFill>
                          <a:schemeClr val="bg1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solidFill>
                      <a:srgbClr val="FF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 dirty="0" smtClean="0">
                          <a:solidFill>
                            <a:schemeClr val="bg1"/>
                          </a:solidFill>
                          <a:effectLst/>
                          <a:latin typeface="Arial"/>
                        </a:rPr>
                        <a:t>115.0</a:t>
                      </a:r>
                      <a:endParaRPr lang="en-US" altLang="ja-JP" sz="1100" b="0" i="0" u="none" strike="noStrike" dirty="0">
                        <a:solidFill>
                          <a:schemeClr val="bg1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solidFill>
                      <a:srgbClr val="FF00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25" name="表 2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23121545"/>
              </p:ext>
            </p:extLst>
          </p:nvPr>
        </p:nvGraphicFramePr>
        <p:xfrm>
          <a:off x="1988840" y="4166939"/>
          <a:ext cx="1482433" cy="1809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64369"/>
                <a:gridCol w="418064"/>
              </a:tblGrid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solidFill>
                            <a:schemeClr val="bg1"/>
                          </a:solidFill>
                          <a:effectLst/>
                        </a:rPr>
                        <a:t>c10910_g1_i2</a:t>
                      </a:r>
                      <a:endParaRPr lang="en-US" sz="1100" b="0" i="0" u="none" strike="noStrike" dirty="0">
                        <a:solidFill>
                          <a:schemeClr val="bg1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solidFill>
                      <a:srgbClr val="FF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 smtClean="0">
                          <a:solidFill>
                            <a:schemeClr val="bg1"/>
                          </a:solidFill>
                          <a:effectLst/>
                        </a:rPr>
                        <a:t>99.5</a:t>
                      </a:r>
                      <a:endParaRPr lang="en-US" altLang="ja-JP" sz="1100" b="0" i="0" u="none" strike="noStrike" dirty="0">
                        <a:solidFill>
                          <a:schemeClr val="bg1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solidFill>
                      <a:srgbClr val="FF00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26" name="表 2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86189735"/>
              </p:ext>
            </p:extLst>
          </p:nvPr>
        </p:nvGraphicFramePr>
        <p:xfrm>
          <a:off x="3486151" y="4160465"/>
          <a:ext cx="1169408" cy="1809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9921"/>
                <a:gridCol w="339487"/>
              </a:tblGrid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c1373_g1_i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 smtClean="0">
                          <a:effectLst/>
                        </a:rPr>
                        <a:t>10.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solidFill>
                      <a:srgbClr val="00FF00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27" name="表 2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47685160"/>
              </p:ext>
            </p:extLst>
          </p:nvPr>
        </p:nvGraphicFramePr>
        <p:xfrm>
          <a:off x="1988840" y="5003601"/>
          <a:ext cx="1458412" cy="1809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98256"/>
                <a:gridCol w="360156"/>
              </a:tblGrid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solidFill>
                            <a:schemeClr val="bg1"/>
                          </a:solidFill>
                          <a:effectLst/>
                        </a:rPr>
                        <a:t>c15980_g1_i1</a:t>
                      </a:r>
                      <a:endParaRPr lang="en-US" sz="1100" b="0" i="0" u="none" strike="noStrike" dirty="0">
                        <a:solidFill>
                          <a:schemeClr val="bg1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solidFill>
                      <a:srgbClr val="FF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 smtClean="0">
                          <a:solidFill>
                            <a:schemeClr val="bg1"/>
                          </a:solidFill>
                          <a:effectLst/>
                        </a:rPr>
                        <a:t>88.0</a:t>
                      </a:r>
                      <a:endParaRPr lang="en-US" altLang="ja-JP" sz="1100" b="0" i="0" u="none" strike="noStrike" dirty="0">
                        <a:solidFill>
                          <a:schemeClr val="bg1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solidFill>
                      <a:srgbClr val="FF00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28" name="表 2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3959127"/>
              </p:ext>
            </p:extLst>
          </p:nvPr>
        </p:nvGraphicFramePr>
        <p:xfrm>
          <a:off x="3486150" y="5003601"/>
          <a:ext cx="1169408" cy="1809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10778"/>
                <a:gridCol w="358630"/>
              </a:tblGrid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c6570_g1_i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 smtClean="0">
                          <a:effectLst/>
                        </a:rPr>
                        <a:t>39.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solidFill>
                      <a:srgbClr val="00FF00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29" name="表 2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88030233"/>
              </p:ext>
            </p:extLst>
          </p:nvPr>
        </p:nvGraphicFramePr>
        <p:xfrm>
          <a:off x="1988840" y="5635675"/>
          <a:ext cx="1512169" cy="1809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36104"/>
                <a:gridCol w="576065"/>
              </a:tblGrid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solidFill>
                            <a:schemeClr val="bg1"/>
                          </a:solidFill>
                          <a:effectLst/>
                        </a:rPr>
                        <a:t>c14621_g1_i4</a:t>
                      </a:r>
                      <a:endParaRPr lang="en-US" sz="1100" b="0" i="0" u="none" strike="noStrike" dirty="0">
                        <a:solidFill>
                          <a:schemeClr val="bg1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solidFill>
                      <a:srgbClr val="FF0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 smtClean="0">
                          <a:solidFill>
                            <a:schemeClr val="bg1"/>
                          </a:solidFill>
                          <a:effectLst/>
                        </a:rPr>
                        <a:t>833.2*</a:t>
                      </a:r>
                      <a:endParaRPr lang="en-US" altLang="ja-JP" sz="1100" b="0" i="0" u="none" strike="noStrike" dirty="0">
                        <a:solidFill>
                          <a:schemeClr val="bg1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solidFill>
                      <a:srgbClr val="FF00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30" name="表 2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92114492"/>
              </p:ext>
            </p:extLst>
          </p:nvPr>
        </p:nvGraphicFramePr>
        <p:xfrm>
          <a:off x="3505200" y="5635675"/>
          <a:ext cx="1169408" cy="1809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30650"/>
                <a:gridCol w="338758"/>
              </a:tblGrid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c12419_g1_i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 smtClean="0">
                          <a:effectLst/>
                        </a:rPr>
                        <a:t>41.9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solidFill>
                      <a:srgbClr val="00FF00"/>
                    </a:solidFill>
                  </a:tcPr>
                </a:tc>
              </a:tr>
            </a:tbl>
          </a:graphicData>
        </a:graphic>
      </p:graphicFrame>
      <p:sp>
        <p:nvSpPr>
          <p:cNvPr id="31" name="テキスト ボックス 30"/>
          <p:cNvSpPr txBox="1"/>
          <p:nvPr/>
        </p:nvSpPr>
        <p:spPr>
          <a:xfrm>
            <a:off x="1988840" y="836876"/>
            <a:ext cx="720080" cy="246221"/>
          </a:xfrm>
          <a:prstGeom prst="rect">
            <a:avLst/>
          </a:prstGeom>
          <a:solidFill>
            <a:srgbClr val="FF00FF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ig</a:t>
            </a:r>
            <a:r>
              <a:rPr kumimoji="1" lang="en-US" altLang="ja-JP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ID</a:t>
            </a:r>
            <a:endParaRPr kumimoji="1" lang="ja-JP" altLang="en-US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2175922" y="539552"/>
            <a:ext cx="2621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TMM-normalized FPKM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正方形/長方形 33"/>
          <p:cNvSpPr/>
          <p:nvPr/>
        </p:nvSpPr>
        <p:spPr>
          <a:xfrm>
            <a:off x="1753546" y="611560"/>
            <a:ext cx="3475654" cy="98789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角丸四角形 36"/>
          <p:cNvSpPr/>
          <p:nvPr/>
        </p:nvSpPr>
        <p:spPr>
          <a:xfrm>
            <a:off x="1988840" y="5616625"/>
            <a:ext cx="2680983" cy="216023"/>
          </a:xfrm>
          <a:prstGeom prst="roundRect">
            <a:avLst/>
          </a:prstGeom>
          <a:noFill/>
          <a:ln>
            <a:solidFill>
              <a:srgbClr val="0070C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直線矢印コネクタ 39"/>
          <p:cNvCxnSpPr/>
          <p:nvPr/>
        </p:nvCxnSpPr>
        <p:spPr>
          <a:xfrm flipH="1">
            <a:off x="4691236" y="5732066"/>
            <a:ext cx="288032" cy="0"/>
          </a:xfrm>
          <a:prstGeom prst="straightConnector1">
            <a:avLst/>
          </a:prstGeom>
          <a:ln w="63500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テキスト ボックス 35"/>
          <p:cNvSpPr txBox="1"/>
          <p:nvPr/>
        </p:nvSpPr>
        <p:spPr>
          <a:xfrm>
            <a:off x="2132856" y="9459252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Fukushima et al. S6 Fig.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角丸四角形 37"/>
          <p:cNvSpPr/>
          <p:nvPr/>
        </p:nvSpPr>
        <p:spPr>
          <a:xfrm>
            <a:off x="1988840" y="1944217"/>
            <a:ext cx="2680983" cy="216023"/>
          </a:xfrm>
          <a:prstGeom prst="roundRect">
            <a:avLst/>
          </a:prstGeom>
          <a:noFill/>
          <a:ln>
            <a:solidFill>
              <a:srgbClr val="0070C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直線矢印コネクタ 40"/>
          <p:cNvCxnSpPr/>
          <p:nvPr/>
        </p:nvCxnSpPr>
        <p:spPr>
          <a:xfrm flipH="1">
            <a:off x="4691236" y="2059658"/>
            <a:ext cx="288032" cy="0"/>
          </a:xfrm>
          <a:prstGeom prst="straightConnector1">
            <a:avLst/>
          </a:prstGeom>
          <a:ln w="63500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38"/>
          <p:cNvSpPr txBox="1"/>
          <p:nvPr/>
        </p:nvSpPr>
        <p:spPr>
          <a:xfrm>
            <a:off x="2731780" y="836876"/>
            <a:ext cx="720080" cy="246221"/>
          </a:xfrm>
          <a:prstGeom prst="rect">
            <a:avLst/>
          </a:prstGeom>
          <a:solidFill>
            <a:srgbClr val="FF00FF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PKM</a:t>
            </a:r>
            <a:endParaRPr kumimoji="1" lang="ja-JP" altLang="en-US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3478148" y="836876"/>
            <a:ext cx="720080" cy="246221"/>
          </a:xfrm>
          <a:prstGeom prst="rect">
            <a:avLst/>
          </a:prstGeom>
          <a:solidFill>
            <a:srgbClr val="00FF00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tig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ID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4221088" y="836876"/>
            <a:ext cx="720080" cy="246221"/>
          </a:xfrm>
          <a:prstGeom prst="rect">
            <a:avLst/>
          </a:prstGeom>
          <a:solidFill>
            <a:srgbClr val="00FF00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PKM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正方形/長方形 43"/>
          <p:cNvSpPr/>
          <p:nvPr/>
        </p:nvSpPr>
        <p:spPr>
          <a:xfrm>
            <a:off x="2127475" y="1160042"/>
            <a:ext cx="1373533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900" i="1" dirty="0" err="1">
                <a:latin typeface="Arial" panose="020B0604020202020204" pitchFamily="34" charset="0"/>
                <a:cs typeface="Arial" panose="020B0604020202020204" pitchFamily="34" charset="0"/>
              </a:rPr>
              <a:t>purpurea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red </a:t>
            </a:r>
            <a:r>
              <a:rPr lang="en-US" altLang="ja-JP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rilla</a:t>
            </a:r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正方形/長方形 44"/>
          <p:cNvSpPr/>
          <p:nvPr/>
        </p:nvSpPr>
        <p:spPr>
          <a:xfrm>
            <a:off x="3680548" y="1165751"/>
            <a:ext cx="1368152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9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iridis</a:t>
            </a:r>
            <a:r>
              <a:rPr lang="en-US" altLang="ja-JP" sz="9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green </a:t>
            </a:r>
            <a:r>
              <a:rPr lang="en-US" altLang="ja-JP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rilla</a:t>
            </a:r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左中かっこ 45"/>
          <p:cNvSpPr/>
          <p:nvPr/>
        </p:nvSpPr>
        <p:spPr>
          <a:xfrm rot="16200000">
            <a:off x="2671883" y="449226"/>
            <a:ext cx="96933" cy="1463020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" name="左中かっこ 46"/>
          <p:cNvSpPr/>
          <p:nvPr/>
        </p:nvSpPr>
        <p:spPr>
          <a:xfrm rot="16200000">
            <a:off x="4173284" y="461319"/>
            <a:ext cx="96842" cy="1438926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1904007" y="1295085"/>
            <a:ext cx="12250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 FDR &lt; 0.0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2132856" y="8774668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Fukushima et al. </a:t>
            </a:r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S6 </a:t>
            </a:r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75737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25</TotalTime>
  <Words>167</Words>
  <Application>Microsoft Office PowerPoint</Application>
  <PresentationFormat>画面に合わせる (4:3)</PresentationFormat>
  <Paragraphs>41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uku</dc:creator>
  <cp:lastModifiedBy>fuku</cp:lastModifiedBy>
  <cp:revision>182</cp:revision>
  <dcterms:created xsi:type="dcterms:W3CDTF">2014-12-01T05:59:03Z</dcterms:created>
  <dcterms:modified xsi:type="dcterms:W3CDTF">2015-05-12T04:21:48Z</dcterms:modified>
</cp:coreProperties>
</file>